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97" r:id="rId2"/>
    <p:sldId id="29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7EB8D-6AD6-47C3-9968-20C02F95AA3F}" type="datetimeFigureOut">
              <a:rPr lang="el-GR" smtClean="0"/>
              <a:t>24/2/2025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DB5A5C-C85F-4C71-80A3-903BBE0D2340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27514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DB5A5C-C85F-4C71-80A3-903BBE0D2340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60126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A3205C-5D3E-1144-AD7A-71352D07E5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88CD1C-C1ED-D0D1-4D23-AEC7A1A240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5A1513-A741-B4D1-242E-6DD88645A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8F0EFD-9734-5611-146C-E6C720DEA0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8C7FF9-61BC-534A-99DD-2A16E768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27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A3CD1-DC8D-41B7-79D7-0BCC4DCAB2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2EFA17-B558-AD77-15A2-51C3BFD975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A1BC6C-C571-6AA3-CC9B-979355898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B8F01-4BA3-6AA2-87E0-CF2CD4AA4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CFAC06-FD76-F450-91EF-6336B4878B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931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F696BF-AC06-1BF8-E3E1-D4B825EBDC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9883F8-22F9-E1E4-44B8-698AD79762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62ED8-E972-42B6-CEC3-19936F97A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E62775-4A98-A904-DA5A-3AAC944D0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BCB995-1013-F72F-E992-83D3ED5FF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299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F7DA24-33FD-23BC-79DC-7A294BBDAF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D0CA11-7B70-FAC3-A329-1556705717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0343EC-5950-BC54-3B10-CD3395D689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94464B-367F-1FD0-7AF0-810457598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C8AB5-481D-83B9-5990-975CFF3FE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542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3B70F9-AA2F-9D1E-4CB2-CF6C0E955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FBFB9A-A8D6-E16B-659B-821ED2E917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0827D-1F7F-F539-949C-3FB4E64AB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6063CF-A0C9-6A06-EB35-A8C9C259D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922231-09E7-E3DE-93B8-DF776A9CC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003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1492B-E17F-7C3F-BA5C-FD93F9502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7EC71-2C9F-675D-FDB3-924D8DD046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097BCC-27E7-CDA8-0756-6C3DCE5134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5CC69B-D6F5-EB59-C7A0-1280B2901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1C9D40-3B25-4D89-BE44-86BB0977D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BD65DD-7E01-0AE9-E138-4B606A933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594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1DC4E4-CC09-E6C7-B5FD-1E2C95D915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E08BBA-06DD-D780-C93C-12CA243469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A9A443-5550-2643-F172-20980C755F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06AC89-C0C8-7B8D-BE69-4059B38CE7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965324-E530-3B2E-6F23-550752BD23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2BEFFC-79CD-5535-0B79-D28457892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6FF718-3102-8A6D-E1EC-ABA16A822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75C2C7-31B8-8766-E5AE-E53FCD243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426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60A5B-9535-C59B-C23A-5B2805669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8969CC-D21F-CA1C-330B-A789076E7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C04B49-883D-3307-B03E-3344573AD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4599C3-E324-75ED-B06B-6430079EF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40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DDC3C28-4C59-5A1C-9228-53096365B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B75852-2610-52B6-68F0-D4FE80C04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1FC9E9-D418-A746-5D83-50F039B54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200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A44C3-FDE2-D70B-3E43-867B24692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977BBE-0CC9-08B1-5141-53D343E7C4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EDB1AF-3F25-9F65-21D6-C4263C310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D379BD-BC80-C971-5D69-1D56C1F50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0E31AD-3F96-9F6E-231D-6D6836146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03F704-AEB3-E40E-E5F5-A1CDAE674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200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7146FE-F530-A9ED-C8FB-7B2979EB0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A2DDE9-39F3-5FF2-D243-3497537B1E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E0AA36-2CE2-5831-614A-AC0EFF0596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61CB84-421A-7D1A-1A5E-B4C754420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53B2BB-F076-D04A-8D08-EEF4D166F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95E2E4-8237-FABC-DA95-D2F7B71E0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350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DECFA4-5505-26E7-9912-E05398FB7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F3C22B-390A-8988-3ABE-FF48970E32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663A80-9AE5-6F47-1263-FA8EFEA280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CBCD0A-58F9-4DE1-8917-72BD1CFE0520}" type="datetimeFigureOut">
              <a:rPr lang="en-US" smtClean="0"/>
              <a:t>2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7532FC-A062-BDBE-6EDD-EA0286AA21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C2AC0F-42D4-3B25-047F-846AD019AF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82733DD-B0DF-493E-A670-3A9DC65E8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6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package" Target="../embeddings/Microsoft_Word_Document1.docx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Ομάδα 4">
            <a:extLst>
              <a:ext uri="{FF2B5EF4-FFF2-40B4-BE49-F238E27FC236}">
                <a16:creationId xmlns:a16="http://schemas.microsoft.com/office/drawing/2014/main" id="{19B2E8DA-13FA-2478-8EE6-4061FC9C5FF6}"/>
              </a:ext>
            </a:extLst>
          </p:cNvPr>
          <p:cNvGrpSpPr/>
          <p:nvPr/>
        </p:nvGrpSpPr>
        <p:grpSpPr>
          <a:xfrm>
            <a:off x="1326601" y="544320"/>
            <a:ext cx="7459180" cy="5776071"/>
            <a:chOff x="1326601" y="544320"/>
            <a:chExt cx="7459180" cy="5776071"/>
          </a:xfrm>
        </p:grpSpPr>
        <p:graphicFrame>
          <p:nvGraphicFramePr>
            <p:cNvPr id="4" name="Αντικείμενο 3">
              <a:extLst>
                <a:ext uri="{FF2B5EF4-FFF2-40B4-BE49-F238E27FC236}">
                  <a16:creationId xmlns:a16="http://schemas.microsoft.com/office/drawing/2014/main" id="{C252AAFD-FFA2-1912-584E-C4ED4646745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95887846"/>
                </p:ext>
              </p:extLst>
            </p:nvPr>
          </p:nvGraphicFramePr>
          <p:xfrm>
            <a:off x="1326601" y="544320"/>
            <a:ext cx="7391773" cy="57693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Document" r:id="rId3" imgW="6005218" imgH="6937447" progId="Word.Document.12">
                    <p:embed/>
                  </p:oleObj>
                </mc:Choice>
                <mc:Fallback>
                  <p:oleObj name="Document" r:id="rId3" imgW="6005218" imgH="6937447" progId="Word.Document.12">
                    <p:embed/>
                    <p:pic>
                      <p:nvPicPr>
                        <p:cNvPr id="4" name="Αντικείμενο 3">
                          <a:extLst>
                            <a:ext uri="{FF2B5EF4-FFF2-40B4-BE49-F238E27FC236}">
                              <a16:creationId xmlns:a16="http://schemas.microsoft.com/office/drawing/2014/main" id="{C252AAFD-FFA2-1912-584E-C4ED4646745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326601" y="544320"/>
                          <a:ext cx="7391773" cy="576936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C9BC56E-7E1C-8D25-053C-2FF3AD2926C9}"/>
                </a:ext>
              </a:extLst>
            </p:cNvPr>
            <p:cNvSpPr txBox="1"/>
            <p:nvPr/>
          </p:nvSpPr>
          <p:spPr>
            <a:xfrm>
              <a:off x="1326601" y="5366284"/>
              <a:ext cx="7459180" cy="9541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Figure S1.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Histologic Images of neuroendocrine carcinoma on lesser curvature lymph node biopsy before induction chemotherapy; 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(A)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and 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(B)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: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Arial" panose="020B0604020202020204" pitchFamily="34" charset="0"/>
                </a:rPr>
                <a:t>Hematoxylin-eosin stain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 (magnification ×20 and ×200 respectively), 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(C)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and 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(D)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:</a:t>
              </a:r>
              <a:r>
                <a:rPr lang="en-US" sz="14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Immunohistochemistry positive for Synaptophysin (magnification ×40) and Ki67 (magnification ×</a:t>
              </a:r>
              <a:r>
                <a:rPr lang="en-US" sz="1400" dirty="0">
                  <a:solidFill>
                    <a:srgbClr val="000000"/>
                  </a:solidFill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lang="en-US" sz="14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Arial" panose="020B0604020202020204" pitchFamily="34" charset="0"/>
                </a:rPr>
                <a:t>00) respectively. </a:t>
              </a:r>
              <a:endParaRPr lang="en-US" sz="1400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3088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Αντικείμενο 1">
            <a:extLst>
              <a:ext uri="{FF2B5EF4-FFF2-40B4-BE49-F238E27FC236}">
                <a16:creationId xmlns:a16="http://schemas.microsoft.com/office/drawing/2014/main" id="{2F122C55-06CC-6132-7473-247BDDFA05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7631398"/>
              </p:ext>
            </p:extLst>
          </p:nvPr>
        </p:nvGraphicFramePr>
        <p:xfrm>
          <a:off x="212725" y="244475"/>
          <a:ext cx="8951913" cy="5975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9163259" imgH="6130876" progId="Word.Document.12">
                  <p:embed/>
                </p:oleObj>
              </mc:Choice>
              <mc:Fallback>
                <p:oleObj name="Document" r:id="rId2" imgW="9163259" imgH="6130876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2725" y="244475"/>
                        <a:ext cx="8951913" cy="5975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 Box 2">
            <a:extLst>
              <a:ext uri="{FF2B5EF4-FFF2-40B4-BE49-F238E27FC236}">
                <a16:creationId xmlns:a16="http://schemas.microsoft.com/office/drawing/2014/main" id="{926FD5D0-19F4-ECA9-60A4-B21709D57F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00308" y="4507910"/>
            <a:ext cx="6057013" cy="1488853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Histologic features of regression of the neuroendocrine carcinoma in lymph node surgical specimen after induction chemotherapy;</a:t>
            </a:r>
            <a:r>
              <a:rPr lang="en-US" sz="1400" i="1" kern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ematoxylin-eosin stain of lymph nodes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from surgical specimen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Images 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A, B, C,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agnification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×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20), Synaptophysin and Chromogranin negativity (Images D and E respectively-magnification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×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20)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Arial" panose="020B0604020202020204" pitchFamily="34" charset="0"/>
              </a:rPr>
              <a:t>.</a:t>
            </a:r>
            <a:endParaRPr lang="el-GR" sz="10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2130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</TotalTime>
  <Words>115</Words>
  <Application>Microsoft Office PowerPoint</Application>
  <PresentationFormat>Widescreen</PresentationFormat>
  <Paragraphs>3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Palatino Linotype</vt:lpstr>
      <vt:lpstr>Office Theme</vt:lpstr>
      <vt:lpstr>Documen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stasia Sotiropoulou</dc:creator>
  <cp:lastModifiedBy>MDPI</cp:lastModifiedBy>
  <cp:revision>18</cp:revision>
  <dcterms:created xsi:type="dcterms:W3CDTF">2025-02-10T11:44:17Z</dcterms:created>
  <dcterms:modified xsi:type="dcterms:W3CDTF">2025-02-24T01:33:07Z</dcterms:modified>
</cp:coreProperties>
</file>